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32"/>
    <p:restoredTop sz="94724"/>
  </p:normalViewPr>
  <p:slideViewPr>
    <p:cSldViewPr snapToGrid="0" snapToObjects="1">
      <p:cViewPr varScale="1">
        <p:scale>
          <a:sx n="99" d="100"/>
          <a:sy n="99" d="100"/>
        </p:scale>
        <p:origin x="192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F814244-CD01-8E4D-9DC5-CE2B988B8D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7C14C40-3246-D842-B18C-D106A746D9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09B9E8B-275C-3144-B83B-9B30FB301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C621FD-77FA-FD4A-BFB9-03ED44E05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0F7613F-9BA7-CD4C-806E-A62DD760E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780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021BEB-136D-E64B-9F06-BADC31C84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A57F6BC-8A5E-C44C-A18E-3AE9CC4D0E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7ADF1E-047C-B445-A6F7-AF5DB0704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5D4E12-C3C1-7C44-9389-C8BD9A6FB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AC537FA-A6AD-FB4F-B145-91ADC1979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1099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702A2B4-AA4C-814E-9F4F-6C0D00572D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04F3288-F0F9-4040-84E0-123C4E8327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9371F1A-537C-CF41-8C46-0DF330A92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C704E8-0037-B048-8CD3-28CA79F67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3E87E06-F021-3F48-9775-24799FE33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660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6032FE-406A-A341-8A55-526DF4F91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A7BC740-A489-6948-BEAA-9E88A97433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0C88B08-6534-3B4F-B9FF-5092B9D24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74FB74-B44C-C74D-97EC-7DAAFD86F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DDFA1F-4403-6943-B7F0-1CA2D3603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9352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7C8AB06-A5BF-6C4C-BE48-1F58E7AD5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E9336E9-EA3B-4E4E-8E97-3A0F84C842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FF833A2-FC6E-B245-BB54-2A60548D9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71B0D7-78FD-7345-A096-2CA9D26E2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DB4752-8D4E-6549-AE3D-23CE1249F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361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9A5798-D38E-584E-AE96-5D47283ED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DF13E8A-C22A-ED41-BE39-EEC5EFFB7A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E4585EC-E5C7-A744-AA6B-A70E1A2EA0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DAD7C12-0944-4A40-9E66-909C0A65A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24292D6-98A5-5B4C-8E45-2405596A7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C057D4-1B83-DC40-AD29-FF8BE0654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350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56FF06-0C90-AF4C-A874-CA806FC486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6DB8E52-E4D2-F14F-846F-70BA1A455A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A09EDBC-1B49-AA42-B61D-7064565483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BEAABB8-02C9-1149-B223-98B1FAE0FB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A09B1C4-A373-D640-999B-C33D723676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BFA8990-808F-5343-9F39-7D3C5A49A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B663D08-DA23-6046-AE94-E823A5318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D618561-5643-044A-BFDC-D1406E62C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6954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9FBE87-3F56-3549-AAB2-B5E141ECB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833956B-6265-0440-A07A-334D05426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AA0F1FF-102B-3546-821F-DBBAE4CC5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532AF12-4E65-534E-9185-33EABD072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1367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15BED53-8090-BA4B-9154-5B5D9E866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3C45E5A-B644-0849-9059-ECA28D764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F34A373A-29D6-1B48-B3B6-9317CC353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5158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E16FC6-8882-CE4B-B8CF-6145CE416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6FFC75F-709B-814A-AFFD-DBD580A702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ABBBB11-68FF-F143-B163-EAF027F349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B061FB9-BB32-9741-BAE5-C64E7F6D6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CBF991B-DB37-6740-A99F-EB77111F4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F196F5-AB22-F142-A53E-4F3A2D665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4360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48F952-C288-5641-9908-3A3F05B9A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16BF287-08C8-3244-8FAD-5097E481AB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A0EC88-C161-614A-B34B-68BF49AE6A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C52902A-AB87-9A49-A8B1-A7255553D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C4A064-C618-4340-9507-4D7A2C71F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8B2018A-6D6E-5545-8112-821EFAF1C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070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29073DC-55DA-4E4F-BBB6-7F1ECF837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56D0F18-C5CF-A741-8A29-6A991FB1A4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388C44F-64C3-8240-A6D4-14D27C4835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3617C-08D3-ED49-9218-41056BA61577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F81D20-26B4-0349-90E1-7A11A5A64B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0DD3AC5-E093-2D4A-BAA9-64D8D4E064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576DA-CFEC-D244-9FE8-149807F565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266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526F86A6-A779-B542-82C1-C4D9270C28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0543" y="2728400"/>
            <a:ext cx="3805695" cy="2859868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3AE6D904-743D-A442-843E-4F33E7EFBE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4294" y="2728399"/>
            <a:ext cx="3798262" cy="2859868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D143924B-75D1-1947-A019-883F4C073F6C}"/>
              </a:ext>
            </a:extLst>
          </p:cNvPr>
          <p:cNvSpPr txBox="1"/>
          <p:nvPr/>
        </p:nvSpPr>
        <p:spPr>
          <a:xfrm>
            <a:off x="1820543" y="2331077"/>
            <a:ext cx="3805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+/+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9C5B047-6D83-F144-B63B-71EC00C288E6}"/>
              </a:ext>
            </a:extLst>
          </p:cNvPr>
          <p:cNvSpPr txBox="1"/>
          <p:nvPr/>
        </p:nvSpPr>
        <p:spPr>
          <a:xfrm>
            <a:off x="6096861" y="2359067"/>
            <a:ext cx="3805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+/</a:t>
            </a:r>
            <a:r>
              <a:rPr lang="fr-FR" dirty="0" err="1"/>
              <a:t>T</a:t>
            </a:r>
            <a:endParaRPr lang="fr-FR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5FC8868A-F997-B349-9FB8-3E72B8923468}"/>
              </a:ext>
            </a:extLst>
          </p:cNvPr>
          <p:cNvSpPr txBox="1"/>
          <p:nvPr/>
        </p:nvSpPr>
        <p:spPr>
          <a:xfrm>
            <a:off x="1820543" y="5616259"/>
            <a:ext cx="1744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cale</a:t>
            </a:r>
            <a:r>
              <a:rPr lang="fr-FR" dirty="0"/>
              <a:t> bar</a:t>
            </a:r>
            <a:r>
              <a:rPr lang="fr-FR"/>
              <a:t>= 30µm</a:t>
            </a:r>
            <a:endParaRPr lang="fr-FR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3065C41-C47C-9E47-897C-891389CBC290}"/>
              </a:ext>
            </a:extLst>
          </p:cNvPr>
          <p:cNvSpPr txBox="1"/>
          <p:nvPr/>
        </p:nvSpPr>
        <p:spPr>
          <a:xfrm>
            <a:off x="0" y="15103"/>
            <a:ext cx="12192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leads to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lteration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body composition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E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istologi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adipose tissue 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pididym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White FAT)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oloratio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ematoxylin-Eosi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H&amp;E)</a:t>
            </a:r>
          </a:p>
        </p:txBody>
      </p:sp>
    </p:spTree>
    <p:extLst>
      <p:ext uri="{BB962C8B-B14F-4D97-AF65-F5344CB8AC3E}">
        <p14:creationId xmlns:p14="http://schemas.microsoft.com/office/powerpoint/2010/main" val="29457175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2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4</cp:revision>
  <dcterms:created xsi:type="dcterms:W3CDTF">2020-05-10T22:08:30Z</dcterms:created>
  <dcterms:modified xsi:type="dcterms:W3CDTF">2020-05-25T17:53:03Z</dcterms:modified>
</cp:coreProperties>
</file>